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9" r:id="rId3"/>
    <p:sldId id="256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 varScale="1">
        <p:scale>
          <a:sx n="77" d="100"/>
          <a:sy n="77" d="100"/>
        </p:scale>
        <p:origin x="854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3B088B-D881-6F88-92F4-04D7563301C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6E47039-B80C-AAB7-DFFC-D0271063CCB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412974-7EB2-9026-C94C-78BED96602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1EA9D-2F66-49BD-8711-67B7A46A4C17}" type="datetimeFigureOut">
              <a:rPr lang="en-US" smtClean="0"/>
              <a:t>10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C2A152-6F13-7095-E103-C682961D90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4AA045-8042-BF42-5081-55C68D98E6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C1B39-CD94-43E9-93F9-99271CC8C0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18593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D9A038-01CC-D736-A01F-33D4D00F95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E65B07C-7BD3-5052-4F0C-046CB9C2408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2A4469-A49D-1C88-F773-6E6FF82687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1EA9D-2F66-49BD-8711-67B7A46A4C17}" type="datetimeFigureOut">
              <a:rPr lang="en-US" smtClean="0"/>
              <a:t>10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A3D292-EC0E-E0A4-7EFB-F15CDEEC81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305FFF-DED8-4FD9-CF34-287FC7FD5F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C1B39-CD94-43E9-93F9-99271CC8C0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19531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AC42964-FC43-6111-C36C-0A81B1F36CB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D9B3372-CD1F-C8B6-2420-5C12849065D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5F8762-9D9E-19D2-8230-6711CED02B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1EA9D-2F66-49BD-8711-67B7A46A4C17}" type="datetimeFigureOut">
              <a:rPr lang="en-US" smtClean="0"/>
              <a:t>10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27A3F5-AC85-5039-A4AC-C57850F5C1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E2AAA0-DD29-8C93-66E8-EAD679A68F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C1B39-CD94-43E9-93F9-99271CC8C0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14433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CAD0FC-26C8-186D-4D91-9B13519197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D3B2147-F991-64F9-7885-D49E6210AAB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8616F5-AC7C-F708-A380-900FFE581F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1EA9D-2F66-49BD-8711-67B7A46A4C17}" type="datetimeFigureOut">
              <a:rPr lang="en-US" smtClean="0"/>
              <a:t>10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9024F7-D26A-8171-8D8D-A82B834833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22B603-408D-EF34-B5F3-2F786C02BE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C1B39-CD94-43E9-93F9-99271CC8C0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3900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919708E-2BC2-A2C7-05CE-DC493F5C4B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EE3B81-61EA-03CD-476A-51F3F3726C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61DDDB-13E5-2B92-D71D-C871535CED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1EA9D-2F66-49BD-8711-67B7A46A4C17}" type="datetimeFigureOut">
              <a:rPr lang="en-US" smtClean="0"/>
              <a:t>10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0B8E58-28F9-91F5-1AF1-658C06322E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204F6B-B54A-7D2C-C98C-BD2789B581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C1B39-CD94-43E9-93F9-99271CC8C0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7203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DD0499-931B-CDB6-E7CC-FCD9A00A62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BBB9905-C071-E995-F693-93D301B9E96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2C5A697-3046-6837-8675-CFDDF385B58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69A7603-21AB-87C2-F81F-83267D1B9D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1EA9D-2F66-49BD-8711-67B7A46A4C17}" type="datetimeFigureOut">
              <a:rPr lang="en-US" smtClean="0"/>
              <a:t>10/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0852DD-930D-410C-22FC-23F1108EB8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1E534CD-F634-A706-6704-63F669F5C9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C1B39-CD94-43E9-93F9-99271CC8C0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44687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EAC6E1-1A92-6F6C-050E-CF64ACD5B4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56F1989-5586-338C-A1E3-2E93EC00C9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7A10F60-9478-E201-7B7C-5253120BEC2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B6ABD49-2E27-8275-4CF1-DDB4908096A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812CEE2-C241-33AD-89F0-57CFAB2673D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4735CA3-1039-1407-065D-4B2DFF0CF3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1EA9D-2F66-49BD-8711-67B7A46A4C17}" type="datetimeFigureOut">
              <a:rPr lang="en-US" smtClean="0"/>
              <a:t>10/4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049DBB4-B8BC-1CCA-A17A-9636FE864F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7EB4666-0C21-6D44-12E7-09F5FCE7D4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C1B39-CD94-43E9-93F9-99271CC8C0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37625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FDF911-51AF-F20D-B8CB-0584061903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0927629-F7D2-473E-DDE4-C20B0234CB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1EA9D-2F66-49BD-8711-67B7A46A4C17}" type="datetimeFigureOut">
              <a:rPr lang="en-US" smtClean="0"/>
              <a:t>10/4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75DB9EB-EACD-AF79-0A79-472E02FEFB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9C50764-5EE0-40A8-48FC-3E1A26E1BD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C1B39-CD94-43E9-93F9-99271CC8C0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30825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DE3025B-0C1C-0827-EC89-58A189B6A8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1EA9D-2F66-49BD-8711-67B7A46A4C17}" type="datetimeFigureOut">
              <a:rPr lang="en-US" smtClean="0"/>
              <a:t>10/4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092F5D6-C4DC-9FB9-5535-F24AAA80CF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AA564F6-C3FF-D1AC-BB61-3CF1423C6B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C1B39-CD94-43E9-93F9-99271CC8C0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78507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B57B75-D723-3C77-8622-679983AA88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9420C88-95AC-C3C7-7A13-14FE17C718E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9805FD6-7A1F-A3BC-F0CA-1D1312B1AE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44C97DC-CF50-6EDA-7D22-9E07AF6A99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1EA9D-2F66-49BD-8711-67B7A46A4C17}" type="datetimeFigureOut">
              <a:rPr lang="en-US" smtClean="0"/>
              <a:t>10/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837C269-EB71-6E63-D5D4-ECAFEA86F8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93F7316-3508-ADAE-2101-1647FE0D6F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C1B39-CD94-43E9-93F9-99271CC8C0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03271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A6A71E-E4E1-35CF-3E03-C7F392C418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2158417-CC99-8872-8EDE-96F795138B5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83A4176-C9FE-7BC2-41AD-E027307004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D89F2C8-3965-6960-EDE6-01819C13ED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1EA9D-2F66-49BD-8711-67B7A46A4C17}" type="datetimeFigureOut">
              <a:rPr lang="en-US" smtClean="0"/>
              <a:t>10/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90B6E76-C478-8625-7746-A37ABF2C75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8C2F010-A344-B66D-C09C-82978C4920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C1B39-CD94-43E9-93F9-99271CC8C0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28981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E7369B2-FF4F-A722-425A-32F74B9833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EDA1F2F-3789-9D49-C46C-9235BB6619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8E0A7A-C7B3-85B9-9682-87D0BCD6879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C1EA9D-2F66-49BD-8711-67B7A46A4C17}" type="datetimeFigureOut">
              <a:rPr lang="en-US" smtClean="0"/>
              <a:t>10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9583B3-8F38-B731-3858-61D59192955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055BAB-FB7A-4904-7C1D-E2A4278DBD1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C1B39-CD94-43E9-93F9-99271CC8C0C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79174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987B90CE-B823-BCB1-4B52-A7C1AA27AE45}"/>
              </a:ext>
            </a:extLst>
          </p:cNvPr>
          <p:cNvGrpSpPr/>
          <p:nvPr/>
        </p:nvGrpSpPr>
        <p:grpSpPr>
          <a:xfrm>
            <a:off x="423446" y="600763"/>
            <a:ext cx="11434560" cy="4046332"/>
            <a:chOff x="445169" y="2063540"/>
            <a:chExt cx="11434560" cy="4046332"/>
          </a:xfrm>
        </p:grpSpPr>
        <p:pic>
          <p:nvPicPr>
            <p:cNvPr id="8" name="Picture 7" descr="A picture containing light, close&#10;&#10;Description automatically generated">
              <a:extLst>
                <a:ext uri="{FF2B5EF4-FFF2-40B4-BE49-F238E27FC236}">
                  <a16:creationId xmlns:a16="http://schemas.microsoft.com/office/drawing/2014/main" id="{CE8A97BD-DD1A-D50C-693E-8CC91F9036B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5169" y="2063540"/>
              <a:ext cx="5650832" cy="4046332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CD196C94-35B7-3B2F-B494-8B2FD362EFA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93305" y="2063540"/>
              <a:ext cx="5286424" cy="4046332"/>
            </a:xfrm>
            <a:prstGeom prst="rect">
              <a:avLst/>
            </a:prstGeom>
          </p:spPr>
        </p:pic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BFD3CF56-3D14-4CCF-2B28-8C460D11778C}"/>
              </a:ext>
            </a:extLst>
          </p:cNvPr>
          <p:cNvSpPr txBox="1"/>
          <p:nvPr/>
        </p:nvSpPr>
        <p:spPr>
          <a:xfrm>
            <a:off x="44726" y="482094"/>
            <a:ext cx="3626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40534B2-0FEC-281C-9A75-0F4BC5341304}"/>
              </a:ext>
            </a:extLst>
          </p:cNvPr>
          <p:cNvSpPr txBox="1"/>
          <p:nvPr/>
        </p:nvSpPr>
        <p:spPr>
          <a:xfrm>
            <a:off x="6207176" y="482094"/>
            <a:ext cx="3513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B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2665ED2-3E52-5790-E246-8A37EE1AE669}"/>
              </a:ext>
            </a:extLst>
          </p:cNvPr>
          <p:cNvSpPr txBox="1"/>
          <p:nvPr/>
        </p:nvSpPr>
        <p:spPr>
          <a:xfrm>
            <a:off x="357809" y="5367130"/>
            <a:ext cx="1124115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l Figure 1</a:t>
            </a:r>
            <a:r>
              <a:rPr lang="en-US" sz="24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 Adequate antero-posterior dimension and adequate pulmonary artery to diaphragm dimension on axial (A) and sagittal (B) computed tomography imaging of patient chest; Pump outline overlayed in green.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21172814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 descr="A picture containing diagram&#10;&#10;Description automatically generated">
            <a:extLst>
              <a:ext uri="{FF2B5EF4-FFF2-40B4-BE49-F238E27FC236}">
                <a16:creationId xmlns:a16="http://schemas.microsoft.com/office/drawing/2014/main" id="{19E9333F-C7CB-4E2C-8BEE-F55A9AF8F10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8CBF7F7E-805E-C43E-3D3E-6A2ECC19101E}"/>
              </a:ext>
            </a:extLst>
          </p:cNvPr>
          <p:cNvSpPr txBox="1"/>
          <p:nvPr/>
        </p:nvSpPr>
        <p:spPr>
          <a:xfrm>
            <a:off x="8718550" y="5865326"/>
            <a:ext cx="33528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l Figure </a:t>
            </a:r>
            <a:r>
              <a:rPr lang="en-US" sz="2400" b="1" dirty="0">
                <a:latin typeface="Times New Roman" panose="02020603050405020304" pitchFamily="18" charset="0"/>
                <a:ea typeface="Calibri" panose="020F0502020204030204" pitchFamily="34" charset="0"/>
              </a:rPr>
              <a:t>2</a:t>
            </a:r>
            <a:r>
              <a:rPr lang="en-US" sz="2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: </a:t>
            </a:r>
          </a:p>
          <a:p>
            <a:r>
              <a:rPr lang="en-US" sz="2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rgical Technique</a:t>
            </a:r>
          </a:p>
        </p:txBody>
      </p:sp>
    </p:spTree>
    <p:extLst>
      <p:ext uri="{BB962C8B-B14F-4D97-AF65-F5344CB8AC3E}">
        <p14:creationId xmlns:p14="http://schemas.microsoft.com/office/powerpoint/2010/main" val="36923191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450BDA1F-735D-DDFB-82AB-5C90B49E9E3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1174" y="565927"/>
            <a:ext cx="5852160" cy="4389120"/>
          </a:xfrm>
          <a:prstGeom prst="rect">
            <a:avLst/>
          </a:prstGeom>
        </p:spPr>
      </p:pic>
      <p:pic>
        <p:nvPicPr>
          <p:cNvPr id="5" name="148C5402">
            <a:hlinkClick r:id="" action="ppaction://media"/>
            <a:extLst>
              <a:ext uri="{FF2B5EF4-FFF2-40B4-BE49-F238E27FC236}">
                <a16:creationId xmlns:a16="http://schemas.microsoft.com/office/drawing/2014/main" id="{86BEFE50-DAD7-DD6B-00E6-E104F85AEDD4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6168668" y="565927"/>
            <a:ext cx="5852160" cy="438912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A971FAA-EF23-9C72-4CD9-BAB309F86C7A}"/>
              </a:ext>
            </a:extLst>
          </p:cNvPr>
          <p:cNvSpPr txBox="1"/>
          <p:nvPr/>
        </p:nvSpPr>
        <p:spPr>
          <a:xfrm>
            <a:off x="94422" y="179018"/>
            <a:ext cx="3626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4069F1C-1ED7-E54F-5457-D2D726450183}"/>
              </a:ext>
            </a:extLst>
          </p:cNvPr>
          <p:cNvSpPr txBox="1"/>
          <p:nvPr/>
        </p:nvSpPr>
        <p:spPr>
          <a:xfrm>
            <a:off x="6096000" y="179018"/>
            <a:ext cx="3513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B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4D36CE5-91D2-ED6F-70A9-CD620387C09B}"/>
              </a:ext>
            </a:extLst>
          </p:cNvPr>
          <p:cNvSpPr txBox="1"/>
          <p:nvPr/>
        </p:nvSpPr>
        <p:spPr>
          <a:xfrm>
            <a:off x="357809" y="5367130"/>
            <a:ext cx="1124115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l Figure 3.</a:t>
            </a:r>
            <a:r>
              <a:rPr lang="en-US" sz="24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Intraoperative trans-esophageal echocardiography (A) displaying mainly right-side inflow and pumping chamber (B).</a:t>
            </a:r>
            <a:endParaRPr lang="en-US" sz="3200" dirty="0"/>
          </a:p>
        </p:txBody>
      </p:sp>
    </p:spTree>
    <p:extLst>
      <p:ext uri="{BB962C8B-B14F-4D97-AF65-F5344CB8AC3E}">
        <p14:creationId xmlns:p14="http://schemas.microsoft.com/office/powerpoint/2010/main" val="240610875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033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 fullScrn="1">
              <p:cMediaNode vol="80000">
                <p:cTn id="12" repeatCount="indefinite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2</TotalTime>
  <Words>67</Words>
  <Application>Microsoft Office PowerPoint</Application>
  <PresentationFormat>Widescreen</PresentationFormat>
  <Paragraphs>8</Paragraphs>
  <Slides>3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rish Dewan</dc:creator>
  <cp:lastModifiedBy>Krish Dewan</cp:lastModifiedBy>
  <cp:revision>12</cp:revision>
  <dcterms:created xsi:type="dcterms:W3CDTF">2022-07-21T01:24:25Z</dcterms:created>
  <dcterms:modified xsi:type="dcterms:W3CDTF">2022-10-05T01:14:31Z</dcterms:modified>
</cp:coreProperties>
</file>